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9" r:id="rId4"/>
    <p:sldId id="258" r:id="rId5"/>
    <p:sldId id="260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0660B408-B3CF-4A94-85FC-2B1E0A45F4A2}" styleName="Dark Style 2 - Accent 1/Accent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Row>
  </a:tblStyle>
  <a:tblStyle styleId="{46F890A9-2807-4EBB-B81D-B2AA78EC7F39}" styleName="Dark Style 2 - Accent 5/Accent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5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Row>
  </a:tblStyle>
  <a:tblStyle styleId="{D7AC3CCA-C797-4891-BE02-D94E43425B78}" styleName="Medium Styl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69CF1AB2-1976-4502-BF36-3FF5EA218861}" styleName="Medium Style 4 - Accent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1"/>
              </a:solidFill>
            </a:ln>
          </a:top>
        </a:tcBdr>
        <a:fill>
          <a:solidFill>
            <a:schemeClr val="accent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1">
              <a:tint val="20000"/>
            </a:schemeClr>
          </a:solidFill>
        </a:fill>
      </a:tcStyle>
    </a:firstRow>
  </a:tblStyle>
  <a:tblStyle styleId="{C4B1156A-380E-4F78-BDF5-A606A8083BF9}" styleName="Medium Style 4 - Accent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4"/>
              </a:solidFill>
            </a:ln>
          </a:left>
          <a:right>
            <a:ln w="12700" cmpd="sng">
              <a:solidFill>
                <a:schemeClr val="accent4"/>
              </a:solidFill>
            </a:ln>
          </a:right>
          <a:top>
            <a:ln w="12700" cmpd="sng">
              <a:solidFill>
                <a:schemeClr val="accent4"/>
              </a:solidFill>
            </a:ln>
          </a:top>
          <a:bottom>
            <a:ln w="12700" cmpd="sng">
              <a:solidFill>
                <a:schemeClr val="accent4"/>
              </a:solidFill>
            </a:ln>
          </a:bottom>
          <a:insideH>
            <a:ln w="12700" cmpd="sng">
              <a:solidFill>
                <a:schemeClr val="accent4"/>
              </a:solidFill>
            </a:ln>
          </a:insideH>
          <a:insideV>
            <a:ln w="12700" cmpd="sng">
              <a:solidFill>
                <a:schemeClr val="accent4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4"/>
              </a:solidFill>
            </a:ln>
          </a:top>
        </a:tcBdr>
        <a:fill>
          <a:solidFill>
            <a:schemeClr val="accent4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4">
              <a:tint val="20000"/>
            </a:schemeClr>
          </a:solidFill>
        </a:fill>
      </a:tcStyle>
    </a:firstRow>
  </a:tblStyle>
  <a:tblStyle styleId="{AF606853-7671-496A-8E4F-DF71F8EC918B}" styleName="Dark Style 1 - Accent 6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6"/>
          </a:solidFill>
        </a:fill>
      </a:tcStyle>
    </a:wholeTbl>
    <a:band1H>
      <a:tcStyle>
        <a:tcBdr/>
        <a:fill>
          <a:solidFill>
            <a:schemeClr val="accent6">
              <a:shade val="60000"/>
            </a:schemeClr>
          </a:solidFill>
        </a:fill>
      </a:tcStyle>
    </a:band1H>
    <a:band1V>
      <a:tcStyle>
        <a:tcBdr/>
        <a:fill>
          <a:solidFill>
            <a:schemeClr val="accent6">
              <a:shade val="6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accent6">
              <a:shade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accent6">
              <a:shade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accent6">
              <a:shade val="4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8FD4443E-F989-4FC4-A0C8-D5A2AF1F390B}" styleName="Dark Style 1 - Accent 5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5"/>
          </a:solidFill>
        </a:fill>
      </a:tcStyle>
    </a:wholeTbl>
    <a:band1H>
      <a:tcStyle>
        <a:tcBdr/>
        <a:fill>
          <a:solidFill>
            <a:schemeClr val="accent5">
              <a:shade val="60000"/>
            </a:schemeClr>
          </a:solidFill>
        </a:fill>
      </a:tcStyle>
    </a:band1H>
    <a:band1V>
      <a:tcStyle>
        <a:tcBdr/>
        <a:fill>
          <a:solidFill>
            <a:schemeClr val="accent5">
              <a:shade val="6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accent5">
              <a:shade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accent5">
              <a:shade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accent5">
              <a:shade val="4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E929F9F4-4A8F-4326-A1B4-22849713DDAB}" styleName="Dark Style 1 - Accent 4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4"/>
          </a:solidFill>
        </a:fill>
      </a:tcStyle>
    </a:wholeTbl>
    <a:band1H>
      <a:tcStyle>
        <a:tcBdr/>
        <a:fill>
          <a:solidFill>
            <a:schemeClr val="accent4">
              <a:shade val="60000"/>
            </a:schemeClr>
          </a:solidFill>
        </a:fill>
      </a:tcStyle>
    </a:band1H>
    <a:band1V>
      <a:tcStyle>
        <a:tcBdr/>
        <a:fill>
          <a:solidFill>
            <a:schemeClr val="accent4">
              <a:shade val="6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accent4">
              <a:shade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accent4">
              <a:shade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accent4">
              <a:shade val="4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D03447BB-5D67-496B-8E87-E561075AD55C}" styleName="Dark Style 1 - Accent 3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/>
          </a:solidFill>
        </a:fill>
      </a:tcStyle>
    </a:wholeTbl>
    <a:band1H>
      <a:tcStyle>
        <a:tcBdr/>
        <a:fill>
          <a:solidFill>
            <a:schemeClr val="accent3">
              <a:shade val="60000"/>
            </a:schemeClr>
          </a:solidFill>
        </a:fill>
      </a:tcStyle>
    </a:band1H>
    <a:band1V>
      <a:tcStyle>
        <a:tcBdr/>
        <a:fill>
          <a:solidFill>
            <a:schemeClr val="accent3">
              <a:shade val="6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accent3">
              <a:shade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accent3">
              <a:shade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accent3">
              <a:shade val="4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91EBBBCC-DAD2-459C-BE2E-F6DE35CF9A28}" styleName="Dark Style 2 - Accent 3/Accent 4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3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firstRow>
  </a:tblStyle>
  <a:tblStyle styleId="{5202B0CA-FC54-4496-8BCA-5EF66A818D29}" styleName="Dark Style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0505E3EF-67EA-436B-97B2-0124C06EBD24}" styleName="Medium Style 4 - Accent 3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3"/>
              </a:solidFill>
            </a:ln>
          </a:top>
        </a:tcBdr>
        <a:fill>
          <a:solidFill>
            <a:schemeClr val="accent3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3">
              <a:tint val="20000"/>
            </a:schemeClr>
          </a:solidFill>
        </a:fill>
      </a:tcStyle>
    </a:firstRow>
  </a:tblStyle>
  <a:tblStyle styleId="{8799B23B-EC83-4686-B30A-512413B5E67A}" styleName="Light Style 3 - Accent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E8034E78-7F5D-4C2E-B375-FC64B27BC917}" styleName="Dark Style 1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dk1">
              <a:tint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dk1">
              <a:tint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dk1">
              <a:tint val="6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EB344D84-9AFB-497E-A393-DC336BA19D2E}" styleName="Medium Style 3 - Accent 3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C083E6E3-FA7D-4D7B-A595-EF9225AFEA82}" styleName="Light Style 1 - Accent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1"/>
    <p:restoredTop sz="94674"/>
  </p:normalViewPr>
  <p:slideViewPr>
    <p:cSldViewPr snapToGrid="0" snapToObjects="1">
      <p:cViewPr>
        <p:scale>
          <a:sx n="122" d="100"/>
          <a:sy n="122" d="100"/>
        </p:scale>
        <p:origin x="-114" y="-7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490953-EA3C-AB40-B6A3-16FC01E83060}" type="datetimeFigureOut">
              <a:rPr lang="en-US" smtClean="0"/>
              <a:t>5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7533E-3D4E-CB44-B6B0-319226E9C6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22506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490953-EA3C-AB40-B6A3-16FC01E83060}" type="datetimeFigureOut">
              <a:rPr lang="en-US" smtClean="0"/>
              <a:t>5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7533E-3D4E-CB44-B6B0-319226E9C6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44487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490953-EA3C-AB40-B6A3-16FC01E83060}" type="datetimeFigureOut">
              <a:rPr lang="en-US" smtClean="0"/>
              <a:t>5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7533E-3D4E-CB44-B6B0-319226E9C6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9348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490953-EA3C-AB40-B6A3-16FC01E83060}" type="datetimeFigureOut">
              <a:rPr lang="en-US" smtClean="0"/>
              <a:t>5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7533E-3D4E-CB44-B6B0-319226E9C6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37276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490953-EA3C-AB40-B6A3-16FC01E83060}" type="datetimeFigureOut">
              <a:rPr lang="en-US" smtClean="0"/>
              <a:t>5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7533E-3D4E-CB44-B6B0-319226E9C6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21662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490953-EA3C-AB40-B6A3-16FC01E83060}" type="datetimeFigureOut">
              <a:rPr lang="en-US" smtClean="0"/>
              <a:t>5/1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7533E-3D4E-CB44-B6B0-319226E9C6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8499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490953-EA3C-AB40-B6A3-16FC01E83060}" type="datetimeFigureOut">
              <a:rPr lang="en-US" smtClean="0"/>
              <a:t>5/18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7533E-3D4E-CB44-B6B0-319226E9C6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97981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490953-EA3C-AB40-B6A3-16FC01E83060}" type="datetimeFigureOut">
              <a:rPr lang="en-US" smtClean="0"/>
              <a:t>5/18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7533E-3D4E-CB44-B6B0-319226E9C6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80972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490953-EA3C-AB40-B6A3-16FC01E83060}" type="datetimeFigureOut">
              <a:rPr lang="en-US" smtClean="0"/>
              <a:t>5/18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7533E-3D4E-CB44-B6B0-319226E9C6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8019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490953-EA3C-AB40-B6A3-16FC01E83060}" type="datetimeFigureOut">
              <a:rPr lang="en-US" smtClean="0"/>
              <a:t>5/1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7533E-3D4E-CB44-B6B0-319226E9C6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64858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490953-EA3C-AB40-B6A3-16FC01E83060}" type="datetimeFigureOut">
              <a:rPr lang="en-US" smtClean="0"/>
              <a:t>5/1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7533E-3D4E-CB44-B6B0-319226E9C6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8260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490953-EA3C-AB40-B6A3-16FC01E83060}" type="datetimeFigureOut">
              <a:rPr lang="en-US" smtClean="0"/>
              <a:t>5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F7533E-3D4E-CB44-B6B0-319226E9C6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06415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78825164"/>
              </p:ext>
            </p:extLst>
          </p:nvPr>
        </p:nvGraphicFramePr>
        <p:xfrm>
          <a:off x="2245360" y="955035"/>
          <a:ext cx="6743164" cy="4496969"/>
        </p:xfrm>
        <a:graphic>
          <a:graphicData uri="http://schemas.openxmlformats.org/drawingml/2006/table">
            <a:tbl>
              <a:tblPr firstRow="1" firstCol="1" bandRow="1">
                <a:tableStyleId>{C083E6E3-FA7D-4D7B-A595-EF9225AFEA82}</a:tableStyleId>
              </a:tblPr>
              <a:tblGrid>
                <a:gridCol w="2273896"/>
                <a:gridCol w="4469268"/>
              </a:tblGrid>
              <a:tr h="176638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Gene</a:t>
                      </a:r>
                      <a:endParaRPr lang="en-US" sz="1200" b="1" dirty="0">
                        <a:solidFill>
                          <a:schemeClr val="tx1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1616" marR="61616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Primer</a:t>
                      </a:r>
                      <a:endParaRPr lang="en-US" sz="1200" b="1" dirty="0">
                        <a:solidFill>
                          <a:schemeClr val="tx1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1616" marR="61616" marT="0" marB="0"/>
                </a:tc>
              </a:tr>
              <a:tr h="176638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 smtClean="0">
                          <a:effectLst/>
                        </a:rPr>
                        <a:t>AK4-forward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61616" marR="61616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TCACACGCCTAATGATGTCCG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61616" marR="61616" marT="0" marB="0"/>
                </a:tc>
              </a:tr>
              <a:tr h="176638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 smtClean="0">
                          <a:effectLst/>
                        </a:rPr>
                        <a:t>AK4-R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61616" marR="61616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CGGCTGAGACGATCTTTAAGTG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61616" marR="61616" marT="0" marB="0"/>
                </a:tc>
              </a:tr>
              <a:tr h="176638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 smtClean="0">
                          <a:effectLst/>
                        </a:rPr>
                        <a:t>cyclinD1-forward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61616" marR="61616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CAATGACCCCGCACGATTTC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61616" marR="61616" marT="0" marB="0"/>
                </a:tc>
              </a:tr>
              <a:tr h="176638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cyclin D1 </a:t>
                      </a:r>
                      <a:r>
                        <a:rPr lang="en-US" sz="900" dirty="0" smtClean="0">
                          <a:effectLst/>
                        </a:rPr>
                        <a:t>-R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61616" marR="61616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CATGGAGGGCGGATTGGAA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61616" marR="61616" marT="0" marB="0"/>
                </a:tc>
              </a:tr>
              <a:tr h="176638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 err="1" smtClean="0">
                          <a:effectLst/>
                        </a:rPr>
                        <a:t>Ssb</a:t>
                      </a:r>
                      <a:r>
                        <a:rPr lang="en-US" sz="900" dirty="0" smtClean="0">
                          <a:effectLst/>
                        </a:rPr>
                        <a:t>--F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61616" marR="61616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GGAAAGGGTAATAAAGCTGCCC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61616" marR="61616" marT="0" marB="0"/>
                </a:tc>
              </a:tr>
              <a:tr h="176638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 err="1" smtClean="0">
                          <a:effectLst/>
                        </a:rPr>
                        <a:t>Ssb</a:t>
                      </a:r>
                      <a:r>
                        <a:rPr lang="en-US" sz="900" dirty="0" smtClean="0">
                          <a:effectLst/>
                        </a:rPr>
                        <a:t>-R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61616" marR="61616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CAGGTCCAGTTGCACCATTTT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61616" marR="61616" marT="0" marB="0"/>
                </a:tc>
              </a:tr>
              <a:tr h="176638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 smtClean="0">
                          <a:effectLst/>
                        </a:rPr>
                        <a:t>TMEM48-forward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61616" marR="61616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GGGCCAGTACAGCTTTCTTGT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61616" marR="61616" marT="0" marB="0"/>
                </a:tc>
              </a:tr>
              <a:tr h="176638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 smtClean="0">
                          <a:effectLst/>
                        </a:rPr>
                        <a:t>TMEM48-R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61616" marR="61616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CCATAAATGCTCCAGTCAGTAGG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61616" marR="61616" marT="0" marB="0"/>
                </a:tc>
              </a:tr>
              <a:tr h="176638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ANKRD12 linear exon 7_ F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61616" marR="61616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 TGGCTGCTATTCGAGGAGAT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61616" marR="61616" marT="0" marB="0"/>
                </a:tc>
              </a:tr>
              <a:tr h="176638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ANKRD12 linear 1exon 7_ R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61616" marR="61616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 TCATGGAGTGGAGTGTCATCA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61616" marR="61616" marT="0" marB="0"/>
                </a:tc>
              </a:tr>
              <a:tr h="176638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 smtClean="0">
                          <a:effectLst/>
                        </a:rPr>
                        <a:t>cirANKRD12_1_forward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61616" marR="61616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TAAACATGGGGAGCGTCCAG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61616" marR="61616" marT="0" marB="0"/>
                </a:tc>
              </a:tr>
              <a:tr h="176638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cirANKRD12_1_R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61616" marR="61616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GTGAACCCAGATTTGGGCATT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61616" marR="61616" marT="0" marB="0"/>
                </a:tc>
              </a:tr>
              <a:tr h="176638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cirANKRD12_3_F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61616" marR="61616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GCGTCCAGTGGATGTAGCAG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61616" marR="61616" marT="0" marB="0"/>
                </a:tc>
              </a:tr>
              <a:tr h="176638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cirANKRD12_3_R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61616" marR="61616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TGAACCCAGATTTGGGCATTT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61616" marR="61616" marT="0" marB="0"/>
                </a:tc>
              </a:tr>
              <a:tr h="176638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 smtClean="0">
                          <a:effectLst/>
                        </a:rPr>
                        <a:t>cirANKRD12_4_forward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61616" marR="61616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CTGTTACTTCGTCACGGTGGA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61616" marR="61616" marT="0" marB="0"/>
                </a:tc>
              </a:tr>
              <a:tr h="176638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ANKRD12_4_R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61616" marR="61616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AGCTGTTCAGCTAGCTTCTTCT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61616" marR="61616" marT="0" marB="0"/>
                </a:tc>
              </a:tr>
              <a:tr h="176638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ANKRD12_linear_exon 9_F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61616" marR="61616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AGGACAAGCTATATTCGCATCAC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61616" marR="61616" marT="0" marB="0"/>
                </a:tc>
              </a:tr>
              <a:tr h="327957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ANKRD12-linear_exon9 _R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61616" marR="61616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TCCATCAAGTGCTTTTCTTTGCT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61616" marR="61616" marT="0" marB="0"/>
                </a:tc>
              </a:tr>
              <a:tr h="423932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ANKRD12 linear siRNA (exon7)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61616" marR="61616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5' </a:t>
                      </a:r>
                      <a:r>
                        <a:rPr lang="en-US" sz="900" dirty="0" err="1">
                          <a:effectLst/>
                        </a:rPr>
                        <a:t>rArArGrCrUrUrGrCrArArUrGrUrUrGrGrArUrArUrUrArCGA</a:t>
                      </a:r>
                      <a:r>
                        <a:rPr lang="en-US" sz="900" dirty="0">
                          <a:effectLst/>
                        </a:rPr>
                        <a:t> 3'</a:t>
                      </a:r>
                      <a:endParaRPr lang="en-US" sz="1100" dirty="0">
                        <a:effectLst/>
                      </a:endParaRPr>
                    </a:p>
                    <a:p>
                      <a:pPr marL="0" marR="285115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5' </a:t>
                      </a:r>
                      <a:r>
                        <a:rPr lang="en-US" sz="900" dirty="0" err="1">
                          <a:effectLst/>
                        </a:rPr>
                        <a:t>rUrCrGrUrArArUrArUrCrCrArArCrArUrUrGrCrArArGrCrUrUrCrA</a:t>
                      </a:r>
                      <a:r>
                        <a:rPr lang="en-US" sz="900" dirty="0">
                          <a:effectLst/>
                        </a:rPr>
                        <a:t> 3'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61616" marR="61616" marT="0" marB="0"/>
                </a:tc>
              </a:tr>
              <a:tr h="559354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ANKRD12 linear siRNA (exon9)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61616" marR="61616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5' </a:t>
                      </a:r>
                      <a:r>
                        <a:rPr lang="en-US" sz="900" dirty="0" err="1">
                          <a:effectLst/>
                        </a:rPr>
                        <a:t>rCrArUrCrArArArUrUrCrUrGrArUrArUrGrCrArArArCrCAA</a:t>
                      </a:r>
                      <a:r>
                        <a:rPr lang="en-US" sz="900" dirty="0">
                          <a:effectLst/>
                        </a:rPr>
                        <a:t> 3'</a:t>
                      </a:r>
                      <a:endParaRPr lang="en-US" sz="1100" dirty="0">
                        <a:effectLst/>
                      </a:endParaRPr>
                    </a:p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5' </a:t>
                      </a:r>
                      <a:r>
                        <a:rPr lang="en-US" sz="900" dirty="0" err="1">
                          <a:effectLst/>
                        </a:rPr>
                        <a:t>rUrUrGrGrUrUrUrGrCrArUrArUrCrArGrArArUrUrUrGrArUrGrUrU</a:t>
                      </a:r>
                      <a:r>
                        <a:rPr lang="en-US" sz="900" dirty="0">
                          <a:effectLst/>
                        </a:rPr>
                        <a:t> 3'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Cambria" charset="0"/>
                        <a:ea typeface="ＭＳ 明朝" charset="-128"/>
                        <a:cs typeface="Times New Roman" charset="0"/>
                      </a:endParaRPr>
                    </a:p>
                  </a:txBody>
                  <a:tcPr marL="61616" marR="61616" marT="0" marB="0"/>
                </a:tc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963037" y="388440"/>
            <a:ext cx="96401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Arial" charset="0"/>
                <a:ea typeface="Arial" charset="0"/>
                <a:cs typeface="Arial" charset="0"/>
              </a:rPr>
              <a:t>Table S1</a:t>
            </a:r>
            <a:r>
              <a:rPr lang="en-US" sz="1400" dirty="0" smtClean="0">
                <a:latin typeface="Arial" charset="0"/>
                <a:ea typeface="Arial" charset="0"/>
                <a:cs typeface="Arial" charset="0"/>
              </a:rPr>
              <a:t>: Primers and siRNA List- primers and siRNA construct used for </a:t>
            </a:r>
            <a:r>
              <a:rPr lang="en-US" sz="1400" dirty="0" err="1" smtClean="0">
                <a:latin typeface="Arial" charset="0"/>
                <a:ea typeface="Arial" charset="0"/>
                <a:cs typeface="Arial" charset="0"/>
              </a:rPr>
              <a:t>qRT</a:t>
            </a:r>
            <a:r>
              <a:rPr lang="en-US" sz="1400" dirty="0" smtClean="0">
                <a:latin typeface="Arial" charset="0"/>
                <a:ea typeface="Arial" charset="0"/>
                <a:cs typeface="Arial" charset="0"/>
              </a:rPr>
              <a:t> PCR analysis </a:t>
            </a:r>
            <a:endParaRPr lang="en-US" sz="1400" dirty="0">
              <a:latin typeface="Arial" charset="0"/>
              <a:ea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5915411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39292889"/>
              </p:ext>
            </p:extLst>
          </p:nvPr>
        </p:nvGraphicFramePr>
        <p:xfrm>
          <a:off x="682167" y="1228720"/>
          <a:ext cx="10059233" cy="3849015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3417331"/>
                <a:gridCol w="3359733"/>
                <a:gridCol w="3282169"/>
              </a:tblGrid>
              <a:tr h="238095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 smtClean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Primer list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 smtClean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Forward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 smtClean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Reverse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b"/>
                </a:tc>
              </a:tr>
              <a:tr h="238095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 smtClean="0">
                          <a:effectLst/>
                        </a:rPr>
                        <a:t>Exon 8&amp;2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</a:rPr>
                        <a:t>ATAGTAAAGCTGTTACTTCGT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</a:rPr>
                        <a:t>CTTTCTTCCATATGGTTTCTC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/>
                </a:tc>
              </a:tr>
              <a:tr h="469309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 smtClean="0">
                          <a:effectLst/>
                        </a:rPr>
                        <a:t>E</a:t>
                      </a:r>
                      <a:r>
                        <a:rPr lang="mr-IN" sz="1400" u="none" strike="noStrike" dirty="0" err="1" smtClean="0">
                          <a:effectLst/>
                        </a:rPr>
                        <a:t>xon</a:t>
                      </a:r>
                      <a:r>
                        <a:rPr lang="en-US" sz="1400" u="none" strike="noStrike" dirty="0" smtClean="0">
                          <a:effectLst/>
                        </a:rPr>
                        <a:t> 3,5,6,7,8&amp;2primer 1</a:t>
                      </a:r>
                      <a:endParaRPr lang="mr-I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</a:rPr>
                        <a:t>CAAGATTGCATCCTACAGC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u="none" strike="noStrike" dirty="0" smtClean="0">
                          <a:effectLst/>
                        </a:rPr>
                        <a:t>CTTTCTTCCATATGGTTTCTC</a:t>
                      </a:r>
                    </a:p>
                    <a:p>
                      <a:pPr algn="l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/>
                </a:tc>
              </a:tr>
              <a:tr h="469309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 smtClean="0">
                          <a:effectLst/>
                        </a:rPr>
                        <a:t>E</a:t>
                      </a:r>
                      <a:r>
                        <a:rPr lang="mr-IN" sz="1400" u="none" strike="noStrike" dirty="0" err="1" smtClean="0">
                          <a:effectLst/>
                        </a:rPr>
                        <a:t>xon</a:t>
                      </a:r>
                      <a:r>
                        <a:rPr lang="en-US" sz="1400" u="none" strike="noStrike" dirty="0" smtClean="0">
                          <a:effectLst/>
                        </a:rPr>
                        <a:t> 3,5,6,7,8&amp;2primer 2</a:t>
                      </a:r>
                      <a:endParaRPr lang="mr-I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</a:rPr>
                        <a:t>GCCCATCAAGAAATGAAGAAC</a:t>
                      </a:r>
                      <a:endParaRPr lang="en-US" sz="1400" b="1" i="0" u="none" strike="noStrike" dirty="0">
                        <a:solidFill>
                          <a:srgbClr val="333333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u="none" strike="noStrike" dirty="0" smtClean="0">
                          <a:effectLst/>
                        </a:rPr>
                        <a:t>CTTTCTTCCATATGGTTTCTC</a:t>
                      </a:r>
                    </a:p>
                    <a:p>
                      <a:pPr algn="l" fontAlgn="b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b"/>
                </a:tc>
              </a:tr>
              <a:tr h="617946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 smtClean="0">
                          <a:effectLst/>
                        </a:rPr>
                        <a:t>E</a:t>
                      </a:r>
                      <a:r>
                        <a:rPr lang="mr-IN" sz="1400" u="none" strike="noStrike" dirty="0" smtClean="0">
                          <a:effectLst/>
                        </a:rPr>
                        <a:t>xon7</a:t>
                      </a:r>
                      <a:r>
                        <a:rPr lang="en-US" sz="1400" u="none" strike="noStrike" dirty="0" smtClean="0">
                          <a:effectLst/>
                        </a:rPr>
                        <a:t>,8</a:t>
                      </a:r>
                      <a:r>
                        <a:rPr lang="en-US" sz="1400" u="none" strike="noStrike" baseline="0" dirty="0" smtClean="0">
                          <a:effectLst/>
                        </a:rPr>
                        <a:t> &amp;2 primer1</a:t>
                      </a:r>
                      <a:endParaRPr lang="mr-I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400" u="none" strike="noStrike" dirty="0">
                          <a:effectLst/>
                        </a:rPr>
                        <a:t>GAAGCTTGCAATGTTGGATATTACG</a:t>
                      </a:r>
                      <a:endParaRPr lang="en-US" sz="1400" b="1" i="0" u="none" strike="noStrike" dirty="0">
                        <a:solidFill>
                          <a:srgbClr val="333333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u="none" strike="noStrike" dirty="0" smtClean="0">
                          <a:effectLst/>
                        </a:rPr>
                        <a:t>CTTTCTTCCATATGGTTTCTC</a:t>
                      </a:r>
                    </a:p>
                    <a:p>
                      <a:pPr algn="l" fontAlgn="b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b"/>
                </a:tc>
              </a:tr>
              <a:tr h="700522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 smtClean="0">
                          <a:effectLst/>
                        </a:rPr>
                        <a:t>E</a:t>
                      </a:r>
                      <a:r>
                        <a:rPr lang="mr-IN" sz="1400" u="none" strike="noStrike" dirty="0" smtClean="0">
                          <a:effectLst/>
                        </a:rPr>
                        <a:t>xon7</a:t>
                      </a:r>
                      <a:r>
                        <a:rPr lang="en-US" sz="1400" u="none" strike="noStrike" dirty="0" smtClean="0">
                          <a:effectLst/>
                        </a:rPr>
                        <a:t>,8</a:t>
                      </a:r>
                      <a:r>
                        <a:rPr lang="en-US" sz="1400" u="none" strike="noStrike" baseline="0" dirty="0" smtClean="0">
                          <a:effectLst/>
                        </a:rPr>
                        <a:t> &amp;2 primer2</a:t>
                      </a:r>
                      <a:endParaRPr lang="mr-IN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</a:rPr>
                        <a:t>CTCCACTCCATGATTCTGCTAG</a:t>
                      </a:r>
                      <a:endParaRPr lang="en-US" sz="1400" b="1" i="0" u="none" strike="noStrike" dirty="0">
                        <a:solidFill>
                          <a:srgbClr val="333333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400" u="none" strike="noStrike" dirty="0" smtClean="0">
                        <a:effectLst/>
                      </a:endParaRPr>
                    </a:p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u="none" strike="noStrike" dirty="0" smtClean="0">
                          <a:effectLst/>
                        </a:rPr>
                        <a:t>CTTTCTTCCATATGGTTTCTC</a:t>
                      </a:r>
                    </a:p>
                    <a:p>
                      <a:pPr algn="l" fontAlgn="b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b"/>
                </a:tc>
              </a:tr>
              <a:tr h="469309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</a:rPr>
                        <a:t>ankrd12 </a:t>
                      </a:r>
                      <a:r>
                        <a:rPr lang="en-US" sz="1400" u="none" strike="noStrike" dirty="0" smtClean="0">
                          <a:effectLst/>
                        </a:rPr>
                        <a:t>exon8 primer 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</a:rPr>
                        <a:t>GCAGAAACAGAGGAGTTGGAG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400" u="none" strike="noStrike" dirty="0" smtClean="0">
                        <a:effectLst/>
                      </a:endParaRPr>
                    </a:p>
                    <a:p>
                      <a:pPr algn="l" fontAlgn="b"/>
                      <a:r>
                        <a:rPr lang="en-US" sz="1400" u="none" strike="noStrike" dirty="0" smtClean="0">
                          <a:effectLst/>
                        </a:rPr>
                        <a:t>GATTTCCACCGTGACGAAGT</a:t>
                      </a:r>
                    </a:p>
                    <a:p>
                      <a:pPr algn="l" fontAlgn="b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b"/>
                </a:tc>
              </a:tr>
              <a:tr h="469309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 smtClean="0">
                          <a:effectLst/>
                        </a:rPr>
                        <a:t>ankrd12Exon8- primer 2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u="none" strike="noStrike" dirty="0">
                          <a:effectLst/>
                        </a:rPr>
                        <a:t>AGCAGAAACAGAGGAGTTGGA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u="none" strike="noStrike" dirty="0" smtClean="0">
                          <a:effectLst/>
                        </a:rPr>
                        <a:t>GATTTCCACCGTGACGAAGT</a:t>
                      </a:r>
                    </a:p>
                    <a:p>
                      <a:pPr algn="l" fontAlgn="b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b"/>
                </a:tc>
              </a:tr>
            </a:tbl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593386" y="428625"/>
            <a:ext cx="1078254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 charset="0"/>
                <a:ea typeface="Arial" charset="0"/>
                <a:cs typeface="Arial" charset="0"/>
              </a:rPr>
              <a:t>Table S2 </a:t>
            </a:r>
            <a:r>
              <a:rPr lang="en-US" sz="1400" b="1" dirty="0" smtClean="0">
                <a:latin typeface="Arial" charset="0"/>
                <a:ea typeface="Arial" charset="0"/>
                <a:cs typeface="Arial" charset="0"/>
              </a:rPr>
              <a:t>:List of the primers used for identifying the whole circle and circular isoforms of ANKRD12 .</a:t>
            </a:r>
            <a:endParaRPr lang="en-US" sz="1400" b="1" dirty="0"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6" name="Straight Connector 5"/>
          <p:cNvCxnSpPr/>
          <p:nvPr/>
        </p:nvCxnSpPr>
        <p:spPr>
          <a:xfrm>
            <a:off x="606897" y="1473740"/>
            <a:ext cx="10142167" cy="486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88085598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Table S3</a:t>
            </a:r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: </a:t>
            </a: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Activation z-score of function annotations and upstream regulators of cancer and immune modulation pathways using Ingenuity Pathway analysis (IPA) in differentially expressed MBA-MB-231 cells (si-circANKRD12 vs. Scrambled).</a:t>
            </a:r>
            <a:br>
              <a:rPr lang="en-US" sz="1000" dirty="0">
                <a:latin typeface="Arial" charset="0"/>
                <a:ea typeface="Arial" charset="0"/>
                <a:cs typeface="Arial" charset="0"/>
              </a:rPr>
            </a:br>
            <a:r>
              <a:rPr lang="en-US" sz="1000" dirty="0">
                <a:latin typeface="Arial" charset="0"/>
                <a:ea typeface="Arial" charset="0"/>
                <a:cs typeface="Arial" charset="0"/>
              </a:rPr>
              <a:t> </a:t>
            </a:r>
          </a:p>
        </p:txBody>
      </p:sp>
      <p:pic>
        <p:nvPicPr>
          <p:cNvPr id="5" name="Picture 4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01949" y="1274324"/>
            <a:ext cx="8701962" cy="2254690"/>
          </a:xfrm>
          <a:prstGeom prst="rect">
            <a:avLst/>
          </a:prstGeom>
          <a:noFill/>
          <a:ln>
            <a:noFill/>
          </a:ln>
        </p:spPr>
      </p:pic>
      <p:pic>
        <p:nvPicPr>
          <p:cNvPr id="4" name="Picture 3"/>
          <p:cNvPicPr/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47863" y="3529014"/>
            <a:ext cx="8556048" cy="2731135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137241288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1513840" y="467975"/>
            <a:ext cx="882666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 smtClean="0">
                <a:effectLst/>
                <a:latin typeface="Arial" charset="0"/>
                <a:ea typeface="ＭＳ 明朝" charset="-128"/>
              </a:rPr>
              <a:t>Table S4</a:t>
            </a:r>
            <a:r>
              <a:rPr lang="en-US" sz="1200" dirty="0" smtClean="0">
                <a:effectLst/>
                <a:latin typeface="Arial" charset="0"/>
                <a:ea typeface="ＭＳ 明朝" charset="-128"/>
              </a:rPr>
              <a:t>: Downregulated pathways in cancer cells by KEGG Pathway (si-circANKRD12 </a:t>
            </a:r>
            <a:r>
              <a:rPr lang="en-US" sz="1200" i="1" dirty="0" smtClean="0">
                <a:effectLst/>
                <a:latin typeface="Arial" charset="0"/>
                <a:ea typeface="ＭＳ 明朝" charset="-128"/>
              </a:rPr>
              <a:t>vs.</a:t>
            </a:r>
            <a:r>
              <a:rPr lang="en-US" sz="1200" dirty="0" smtClean="0">
                <a:effectLst/>
                <a:latin typeface="Arial" charset="0"/>
                <a:ea typeface="ＭＳ 明朝" charset="-128"/>
              </a:rPr>
              <a:t> Scrambled</a:t>
            </a:r>
            <a:r>
              <a:rPr lang="en-US" sz="1200" dirty="0" smtClean="0">
                <a:effectLst/>
              </a:rPr>
              <a:t> </a:t>
            </a:r>
            <a:endParaRPr lang="en-US" sz="1200" dirty="0"/>
          </a:p>
        </p:txBody>
      </p:sp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82034106"/>
              </p:ext>
            </p:extLst>
          </p:nvPr>
        </p:nvGraphicFramePr>
        <p:xfrm>
          <a:off x="2198451" y="1313234"/>
          <a:ext cx="8492247" cy="4369794"/>
        </p:xfrm>
        <a:graphic>
          <a:graphicData uri="http://schemas.openxmlformats.org/drawingml/2006/table">
            <a:tbl>
              <a:tblPr>
                <a:tableStyleId>{EB344D84-9AFB-497E-A393-DC336BA19D2E}</a:tableStyleId>
              </a:tblPr>
              <a:tblGrid>
                <a:gridCol w="1313859"/>
                <a:gridCol w="1396875"/>
                <a:gridCol w="3856929"/>
                <a:gridCol w="1063177"/>
                <a:gridCol w="861407"/>
              </a:tblGrid>
              <a:tr h="94887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Category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812" marR="4812" marT="481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Pathways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812" marR="4812" marT="481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Genes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812" marR="4812" marT="481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 err="1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PValue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812" marR="4812" marT="481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cell line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4812" marR="4812" marT="4812" marB="0" anchor="b"/>
                </a:tc>
              </a:tr>
              <a:tr h="789227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KEGG_PATHWAY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812" marR="4812" marT="481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Oxidative phosphorylation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812" marR="4812" marT="481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ATP synthase F0 subunit 8(ATP8)</a:t>
                      </a:r>
                      <a:br>
                        <a:rPr lang="en-US" sz="900" u="none" strike="noStrike" dirty="0">
                          <a:effectLst/>
                        </a:rPr>
                      </a:br>
                      <a:r>
                        <a:rPr lang="en-US" sz="900" u="none" strike="noStrike" dirty="0">
                          <a:effectLst/>
                        </a:rPr>
                        <a:t>NADH dehydrogenase, subunit 1 (complex I)(ND1)</a:t>
                      </a:r>
                      <a:br>
                        <a:rPr lang="en-US" sz="900" u="none" strike="noStrike" dirty="0">
                          <a:effectLst/>
                        </a:rPr>
                      </a:br>
                      <a:r>
                        <a:rPr lang="en-US" sz="900" u="none" strike="noStrike" dirty="0">
                          <a:effectLst/>
                        </a:rPr>
                        <a:t>NADH dehydrogenase, subunit 6 (complex I)(ND6)</a:t>
                      </a:r>
                      <a:br>
                        <a:rPr lang="en-US" sz="900" u="none" strike="noStrike" dirty="0">
                          <a:effectLst/>
                        </a:rPr>
                      </a:br>
                      <a:r>
                        <a:rPr lang="en-US" sz="900" u="none" strike="noStrike" dirty="0">
                          <a:effectLst/>
                        </a:rPr>
                        <a:t>cytochrome b(CYTB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812" marR="4812" marT="481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i-FI" sz="900" u="none" strike="noStrike" dirty="0" smtClean="0">
                          <a:effectLst/>
                        </a:rPr>
                        <a:t>0.001</a:t>
                      </a:r>
                      <a:endParaRPr lang="fi-FI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812" marR="4812" marT="481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 smtClean="0">
                          <a:effectLst/>
                        </a:rPr>
                        <a:t>         OVCAR3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812" marR="4812" marT="4812" marB="0" anchor="b"/>
                </a:tc>
              </a:tr>
              <a:tr h="2638137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KEGG_PATHWAY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812" marR="4812" marT="481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Metabolic pathways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812" marR="4812" marT="481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3-hydroxy-3-methylglutaryl-CoA reductase(HMGCR)</a:t>
                      </a:r>
                      <a:br>
                        <a:rPr lang="en-US" sz="900" u="none" strike="noStrike">
                          <a:effectLst/>
                        </a:rPr>
                      </a:br>
                      <a:r>
                        <a:rPr lang="en-US" sz="900" u="none" strike="noStrike">
                          <a:effectLst/>
                        </a:rPr>
                        <a:t>ATPase H+ transporting V1 subunit D(ATP6V1D)</a:t>
                      </a:r>
                      <a:br>
                        <a:rPr lang="en-US" sz="900" u="none" strike="noStrike">
                          <a:effectLst/>
                        </a:rPr>
                      </a:br>
                      <a:r>
                        <a:rPr lang="en-US" sz="900" u="none" strike="noStrike">
                          <a:effectLst/>
                        </a:rPr>
                        <a:t>OCRL, inositol polyphosphate-5-phosphatase(OCRL)</a:t>
                      </a:r>
                      <a:br>
                        <a:rPr lang="en-US" sz="900" u="none" strike="noStrike">
                          <a:effectLst/>
                        </a:rPr>
                      </a:br>
                      <a:r>
                        <a:rPr lang="en-US" sz="900" u="none" strike="noStrike">
                          <a:effectLst/>
                        </a:rPr>
                        <a:t>acyl-CoA synthetase short-chain family member 2(ACSS2)</a:t>
                      </a:r>
                      <a:br>
                        <a:rPr lang="en-US" sz="900" u="none" strike="noStrike">
                          <a:effectLst/>
                        </a:rPr>
                      </a:br>
                      <a:r>
                        <a:rPr lang="en-US" sz="900" u="none" strike="noStrike">
                          <a:effectLst/>
                        </a:rPr>
                        <a:t>adenylate kinase 4(AK4)</a:t>
                      </a:r>
                      <a:br>
                        <a:rPr lang="en-US" sz="900" u="none" strike="noStrike">
                          <a:effectLst/>
                        </a:rPr>
                      </a:br>
                      <a:r>
                        <a:rPr lang="en-US" sz="900" u="none" strike="noStrike">
                          <a:effectLst/>
                        </a:rPr>
                        <a:t>aldehyde dehydrogenase 3 family member A2(ALDH3A2)</a:t>
                      </a:r>
                      <a:br>
                        <a:rPr lang="en-US" sz="900" u="none" strike="noStrike">
                          <a:effectLst/>
                        </a:rPr>
                      </a:br>
                      <a:r>
                        <a:rPr lang="en-US" sz="900" u="none" strike="noStrike">
                          <a:effectLst/>
                        </a:rPr>
                        <a:t>farnesyl-diphosphate farnesyltransferase 1(FDFT1)</a:t>
                      </a:r>
                      <a:br>
                        <a:rPr lang="en-US" sz="900" u="none" strike="noStrike">
                          <a:effectLst/>
                        </a:rPr>
                      </a:br>
                      <a:r>
                        <a:rPr lang="en-US" sz="900" u="none" strike="noStrike">
                          <a:effectLst/>
                        </a:rPr>
                        <a:t>glucosaminyl (N-acetyl) transferase 1, core 2(GCNT1)</a:t>
                      </a:r>
                      <a:br>
                        <a:rPr lang="en-US" sz="900" u="none" strike="noStrike">
                          <a:effectLst/>
                        </a:rPr>
                      </a:br>
                      <a:r>
                        <a:rPr lang="en-US" sz="900" u="none" strike="noStrike">
                          <a:effectLst/>
                        </a:rPr>
                        <a:t>glucosaminyl (N-acetyl) transferase 2, I-branching enzyme (I blood group)(GCNT2)</a:t>
                      </a:r>
                      <a:br>
                        <a:rPr lang="en-US" sz="900" u="none" strike="noStrike">
                          <a:effectLst/>
                        </a:rPr>
                      </a:br>
                      <a:r>
                        <a:rPr lang="en-US" sz="900" u="none" strike="noStrike">
                          <a:effectLst/>
                        </a:rPr>
                        <a:t>isocitrate dehydrogenase (NADP(+)) 1, cytosolic(IDH1)</a:t>
                      </a:r>
                      <a:br>
                        <a:rPr lang="en-US" sz="900" u="none" strike="noStrike">
                          <a:effectLst/>
                        </a:rPr>
                      </a:br>
                      <a:r>
                        <a:rPr lang="en-US" sz="900" u="none" strike="noStrike">
                          <a:effectLst/>
                        </a:rPr>
                        <a:t>isopentenyl-diphosphate delta isomerase 1(IDI1)</a:t>
                      </a:r>
                      <a:br>
                        <a:rPr lang="en-US" sz="900" u="none" strike="noStrike">
                          <a:effectLst/>
                        </a:rPr>
                      </a:br>
                      <a:r>
                        <a:rPr lang="en-US" sz="900" u="none" strike="noStrike">
                          <a:effectLst/>
                        </a:rPr>
                        <a:t>mannosidase alpha class 1A member 2(MAN1A2)</a:t>
                      </a:r>
                      <a:br>
                        <a:rPr lang="en-US" sz="900" u="none" strike="noStrike">
                          <a:effectLst/>
                        </a:rPr>
                      </a:br>
                      <a:r>
                        <a:rPr lang="en-US" sz="900" u="none" strike="noStrike">
                          <a:effectLst/>
                        </a:rPr>
                        <a:t>methylsterol monooxygenase 1(MSMO1)</a:t>
                      </a:r>
                      <a:br>
                        <a:rPr lang="en-US" sz="900" u="none" strike="noStrike">
                          <a:effectLst/>
                        </a:rPr>
                      </a:br>
                      <a:r>
                        <a:rPr lang="en-US" sz="900" u="none" strike="noStrike">
                          <a:effectLst/>
                        </a:rPr>
                        <a:t>nicotinamide nucleotide transhydrogenase(NNT)</a:t>
                      </a:r>
                      <a:br>
                        <a:rPr lang="en-US" sz="900" u="none" strike="noStrike">
                          <a:effectLst/>
                        </a:rPr>
                      </a:br>
                      <a:r>
                        <a:rPr lang="en-US" sz="900" u="none" strike="noStrike">
                          <a:effectLst/>
                        </a:rPr>
                        <a:t>pantothenate kinase 3(PANK3)</a:t>
                      </a:r>
                      <a:br>
                        <a:rPr lang="en-US" sz="900" u="none" strike="noStrike">
                          <a:effectLst/>
                        </a:rPr>
                      </a:br>
                      <a:r>
                        <a:rPr lang="en-US" sz="900" u="none" strike="noStrike">
                          <a:effectLst/>
                        </a:rPr>
                        <a:t>sphingomyelin synthase 2(SGMS2)</a:t>
                      </a:r>
                      <a:br>
                        <a:rPr lang="en-US" sz="900" u="none" strike="noStrike">
                          <a:effectLst/>
                        </a:rPr>
                      </a:br>
                      <a:r>
                        <a:rPr lang="en-US" sz="900" u="none" strike="noStrike">
                          <a:effectLst/>
                        </a:rPr>
                        <a:t>sterol-C5-desaturase(SC5D)</a:t>
                      </a:r>
                      <a:br>
                        <a:rPr lang="en-US" sz="900" u="none" strike="noStrike">
                          <a:effectLst/>
                        </a:rPr>
                      </a:br>
                      <a:r>
                        <a:rPr lang="en-US" sz="900" u="none" strike="noStrike">
                          <a:effectLst/>
                        </a:rPr>
                        <a:t>succinate dehydrogenase complex subunit C(SDHC)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812" marR="4812" marT="481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900" u="none" strike="noStrike" dirty="0" smtClean="0">
                          <a:effectLst/>
                        </a:rPr>
                        <a:t>0.033</a:t>
                      </a:r>
                      <a:endParaRPr lang="is-I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812" marR="4812" marT="481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 smtClean="0">
                          <a:effectLst/>
                        </a:rPr>
                        <a:t>       </a:t>
                      </a:r>
                      <a:r>
                        <a:rPr lang="mr-IN" sz="900" u="none" strike="noStrike" dirty="0" smtClean="0">
                          <a:effectLst/>
                        </a:rPr>
                        <a:t>MDA-MB-231</a:t>
                      </a:r>
                      <a:endParaRPr lang="mr-IN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812" marR="4812" marT="4812" marB="0" anchor="b"/>
                </a:tc>
              </a:tr>
              <a:tr h="769978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KEGG_PATHWAY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812" marR="4812" marT="481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AMPK signaling pathway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812" marR="4812" marT="481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3-hydroxy-3-methylglutaryl-CoA reductase(HMGCR)</a:t>
                      </a:r>
                      <a:br>
                        <a:rPr lang="en-US" sz="900" u="none" strike="noStrike" dirty="0">
                          <a:effectLst/>
                        </a:rPr>
                      </a:br>
                      <a:r>
                        <a:rPr lang="en-US" sz="900" u="none" strike="noStrike" dirty="0">
                          <a:effectLst/>
                        </a:rPr>
                        <a:t>STE20-related kinase adaptor beta(STRADB)</a:t>
                      </a:r>
                      <a:br>
                        <a:rPr lang="en-US" sz="900" u="none" strike="noStrike" dirty="0">
                          <a:effectLst/>
                        </a:rPr>
                      </a:br>
                      <a:r>
                        <a:rPr lang="en-US" sz="900" u="none" strike="noStrike" dirty="0">
                          <a:effectLst/>
                        </a:rPr>
                        <a:t>cyclin A2(CCNA2)</a:t>
                      </a:r>
                      <a:br>
                        <a:rPr lang="en-US" sz="900" u="none" strike="noStrike" dirty="0">
                          <a:effectLst/>
                        </a:rPr>
                      </a:br>
                      <a:r>
                        <a:rPr lang="en-US" sz="900" u="none" strike="noStrike" dirty="0">
                          <a:effectLst/>
                        </a:rPr>
                        <a:t>cyclin D1(CCND1)</a:t>
                      </a:r>
                      <a:br>
                        <a:rPr lang="en-US" sz="900" u="none" strike="noStrike" dirty="0">
                          <a:effectLst/>
                        </a:rPr>
                      </a:br>
                      <a:r>
                        <a:rPr lang="en-US" sz="900" u="none" strike="noStrike" dirty="0" err="1">
                          <a:effectLst/>
                        </a:rPr>
                        <a:t>stearoyl</a:t>
                      </a:r>
                      <a:r>
                        <a:rPr lang="en-US" sz="900" u="none" strike="noStrike" dirty="0">
                          <a:effectLst/>
                        </a:rPr>
                        <a:t>-CoA desaturase(SCD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812" marR="4812" marT="481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cs-CZ" sz="900" u="none" strike="noStrike" dirty="0" smtClean="0">
                          <a:effectLst/>
                        </a:rPr>
                        <a:t>0.022</a:t>
                      </a:r>
                      <a:endParaRPr lang="cs-CZ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812" marR="4812" marT="481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 smtClean="0">
                          <a:effectLst/>
                        </a:rPr>
                        <a:t>        MDAMB231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4812" marR="4812" marT="4812" marB="0" anchor="b"/>
                </a:tc>
              </a:tr>
            </a:tbl>
          </a:graphicData>
        </a:graphic>
      </p:graphicFrame>
      <p:cxnSp>
        <p:nvCxnSpPr>
          <p:cNvPr id="5" name="Straight Connector 4"/>
          <p:cNvCxnSpPr/>
          <p:nvPr/>
        </p:nvCxnSpPr>
        <p:spPr>
          <a:xfrm flipV="1">
            <a:off x="2208179" y="4951381"/>
            <a:ext cx="8472791" cy="972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>
            <a:off x="2198451" y="2315184"/>
            <a:ext cx="828796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/>
          <p:cNvCxnSpPr/>
          <p:nvPr/>
        </p:nvCxnSpPr>
        <p:spPr>
          <a:xfrm flipV="1">
            <a:off x="2208179" y="1488333"/>
            <a:ext cx="8482519" cy="58367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71706085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1625600" y="403275"/>
            <a:ext cx="751840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 smtClean="0">
                <a:effectLst/>
                <a:latin typeface="Arial" charset="0"/>
                <a:ea typeface="ＭＳ 明朝" charset="-128"/>
                <a:cs typeface="Times New Roman" charset="0"/>
              </a:rPr>
              <a:t>Table S5</a:t>
            </a:r>
            <a:r>
              <a:rPr lang="en-US" sz="1200" dirty="0" smtClean="0">
                <a:effectLst/>
                <a:latin typeface="Arial" charset="0"/>
                <a:ea typeface="ＭＳ 明朝" charset="-128"/>
                <a:cs typeface="Times New Roman" charset="0"/>
              </a:rPr>
              <a:t>: Upregulated pathways in cancer cells by KEGG pathway (si-circANKRD12 vs. Scrambled)</a:t>
            </a:r>
            <a:endParaRPr lang="en-US" sz="1200" dirty="0">
              <a:effectLst/>
              <a:latin typeface="Cambria" charset="0"/>
              <a:ea typeface="ＭＳ 明朝" charset="-128"/>
              <a:cs typeface="Times New Roman" charset="0"/>
            </a:endParaRPr>
          </a:p>
        </p:txBody>
      </p:sp>
      <p:graphicFrame>
        <p:nvGraphicFramePr>
          <p:cNvPr id="10" name="Table 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00581500"/>
              </p:ext>
            </p:extLst>
          </p:nvPr>
        </p:nvGraphicFramePr>
        <p:xfrm>
          <a:off x="1625602" y="2167134"/>
          <a:ext cx="6341351" cy="1334648"/>
        </p:xfrm>
        <a:graphic>
          <a:graphicData uri="http://schemas.openxmlformats.org/drawingml/2006/table">
            <a:tbl>
              <a:tblPr>
                <a:tableStyleId>{8EC20E35-A176-4012-BC5E-935CFFF8708E}</a:tableStyleId>
              </a:tblPr>
              <a:tblGrid>
                <a:gridCol w="1562194"/>
                <a:gridCol w="1758915"/>
                <a:gridCol w="549733"/>
                <a:gridCol w="985394"/>
                <a:gridCol w="1485115"/>
              </a:tblGrid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Category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Pathways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Count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 err="1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PValue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cell Line 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KEGG_PATHWAY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TNF signaling pathway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cs-CZ" sz="8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11</a:t>
                      </a:r>
                      <a:endParaRPr lang="cs-CZ" sz="8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4.03E-06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mr-IN" sz="8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   MDA-MB-231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KEGG_PATHWAY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NF-kappa B signaling pathway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1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5.86E-06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mr-IN" sz="8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    MDA-MB-231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KEGG_PATHWAY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PI3K-Akt signaling pathway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8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12</a:t>
                      </a:r>
                      <a:endParaRPr lang="is-IS" sz="8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800" u="none" strike="noStrike" dirty="0" smtClean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0153</a:t>
                      </a:r>
                      <a:endParaRPr lang="is-I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mr-IN" sz="8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   MDA-MB-231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KEGG_PATHWAY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FoxO signaling pathway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800" u="none" strike="noStrike" dirty="0" smtClean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01595</a:t>
                      </a:r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mr-IN" sz="8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   MDA-MB-231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KEGG_PATHWAY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VEGF signaling </a:t>
                      </a:r>
                      <a:r>
                        <a:rPr lang="en-US" sz="800" u="none" strike="noStrike" dirty="0" smtClean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pathway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800" u="none" strike="noStrike" dirty="0" smtClean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065143</a:t>
                      </a:r>
                      <a:endParaRPr lang="is-I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mr-IN" sz="8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   MDA-MB-231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b"/>
                </a:tc>
              </a:tr>
              <a:tr h="191648">
                <a:tc gridSpan="2">
                  <a:txBody>
                    <a:bodyPr/>
                    <a:lstStyle/>
                    <a:p>
                      <a:pPr algn="l" rtl="0" fontAlgn="ctr"/>
                      <a:r>
                        <a:rPr lang="mr-IN" sz="8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KEGG _PATHWAY        </a:t>
                      </a:r>
                      <a:r>
                        <a:rPr lang="en-US" sz="800" u="none" strike="noStrike" dirty="0" smtClean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                </a:t>
                      </a:r>
                      <a:r>
                        <a:rPr lang="mr-IN" sz="800" u="none" strike="noStrike" dirty="0" smtClean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JAK-STAT SIGNALLING</a:t>
                      </a:r>
                      <a:endParaRPr lang="mr-I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u="none" strike="noStrike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mr-IN" sz="8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            </a:t>
                      </a:r>
                      <a:r>
                        <a:rPr lang="en-US" sz="800" u="none" strike="noStrike" dirty="0" smtClean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      </a:t>
                      </a:r>
                      <a:r>
                        <a:rPr lang="mr-IN" sz="800" u="none" strike="noStrike" dirty="0" smtClean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  </a:t>
                      </a:r>
                      <a:r>
                        <a:rPr lang="en-US" sz="800" u="none" strike="noStrike" dirty="0" smtClean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0.05</a:t>
                      </a:r>
                      <a:r>
                        <a:rPr lang="mr-IN" sz="800" u="none" strike="noStrike" dirty="0" smtClean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   </a:t>
                      </a:r>
                      <a:r>
                        <a:rPr lang="en-US" sz="800" u="none" strike="noStrike" dirty="0" smtClean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                </a:t>
                      </a:r>
                      <a:r>
                        <a:rPr lang="mr-IN" sz="800" u="none" strike="noStrike" dirty="0" smtClean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 </a:t>
                      </a:r>
                      <a:endParaRPr lang="mr-I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mr-IN" sz="8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  </a:t>
                      </a:r>
                      <a:r>
                        <a:rPr lang="en-US" sz="800" u="none" strike="noStrike" dirty="0" smtClean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       </a:t>
                      </a:r>
                      <a:r>
                        <a:rPr lang="mr-IN" sz="800" u="none" strike="noStrike" dirty="0" smtClean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 </a:t>
                      </a:r>
                      <a:r>
                        <a:rPr lang="mr-IN" sz="800" u="none" strike="noStrike" dirty="0">
                          <a:effectLst/>
                          <a:latin typeface="Arial" charset="0"/>
                          <a:ea typeface="Arial" charset="0"/>
                          <a:cs typeface="Arial" charset="0"/>
                        </a:rPr>
                        <a:t>OVCAR3</a:t>
                      </a:r>
                      <a:endParaRPr lang="mr-IN" sz="800" b="0" i="0" u="none" strike="noStrike" dirty="0">
                        <a:solidFill>
                          <a:srgbClr val="000000"/>
                        </a:solidFill>
                        <a:effectLst/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350" marR="6350" marT="6350" marB="0" anchor="b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329460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5</TotalTime>
  <Words>318</Words>
  <Application>Microsoft Office PowerPoint</Application>
  <PresentationFormat>Custom</PresentationFormat>
  <Paragraphs>129</Paragraphs>
  <Slides>5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6" baseType="lpstr">
      <vt:lpstr>Office Theme</vt:lpstr>
      <vt:lpstr>PowerPoint Presentation</vt:lpstr>
      <vt:lpstr>PowerPoint Presentation</vt:lpstr>
      <vt:lpstr>Table S3: Activation z-score of function annotations and upstream regulators of cancer and immune modulation pathways using Ingenuity Pathway analysis (IPA) in differentially expressed MBA-MB-231 cells (si-circANKRD12 vs. Scrambled).  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hasni K.A. Azis</dc:creator>
  <cp:lastModifiedBy>JABELLA</cp:lastModifiedBy>
  <cp:revision>21</cp:revision>
  <dcterms:created xsi:type="dcterms:W3CDTF">2018-05-16T08:30:27Z</dcterms:created>
  <dcterms:modified xsi:type="dcterms:W3CDTF">2019-05-18T01:34:38Z</dcterms:modified>
</cp:coreProperties>
</file>